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  <p:sldId id="263" r:id="rId3"/>
    <p:sldId id="264" r:id="rId4"/>
    <p:sldId id="271" r:id="rId5"/>
    <p:sldId id="274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A040"/>
    <a:srgbClr val="55A0FB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45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7E19196-A784-9D64-AFE9-9F9CC64E9C7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EBBC94A8-EF44-8A0A-1661-F1A4F374DD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A037480-CC22-7F13-480A-D3CD40CD5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8.07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ECD6976-0BFC-B3BD-BD9A-BE89364A2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FE80D3F-5E70-55CF-00B7-7F94346CFA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41923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94E7B50-6711-954B-7F6D-C2B89D65DE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2F89F6E-E1CD-93B2-7B39-769EAE45E5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DAA5416-0968-F11A-4119-D7A5148602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8.07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576D6CB-7845-AA8E-C6FF-B6AC761E2D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C867E78-C164-8167-CC27-E53A1AD0ED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7190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83355020-7C76-E1ED-3997-230C28E09F8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951A59CF-E825-850D-B42D-4FAEF59B80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2279E4A-E608-22F0-550B-8BF8173765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8.07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8352EAA-5ECF-2338-FD9E-6CAFB0D070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7653441-50AA-F437-E665-60E87CF4B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0464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36E5AA4-D76C-268A-6C54-C5491177B8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6EB5A48-A143-C842-2CAC-CB7F229A95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AC4721B-AF28-E925-B1A6-84BEEC829E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8.07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830F58E-3338-542E-52FB-1F89CBA2CE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F148DA1-A633-3386-5A74-C369393212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79548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DCD4D6A-D105-8A00-DFF7-A35383FED5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95CB9CB-55D7-2BD3-60CC-03361BE1EA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6D5673A-8A2D-7326-604A-A8BDE57B89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8.07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1741326-3F47-C3F0-A504-9CDCA8F3A6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63C9774-2A84-4E66-F192-860D01E1CE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39042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E5E5CE3-4778-0C45-022B-606245EF02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5727497-FB50-39B4-0086-1A2A5CDB9B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CB8ADB0-0E2F-0669-7B1B-B47F444295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1B5C1F4-5656-ABBC-26F0-091A8D8CD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8.07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15E94AD-5BBD-E743-AAE1-D79DDF8705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CEF3F5A-D508-7B8A-877B-604840A925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31867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823F2E8-FEAB-9EE6-38E7-41B8D5D295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65E1B23-527C-20EE-5A5D-9EF686CCF8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0C4B4CA-0564-D20B-C7D9-E305D0C76F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61861AFC-01D6-B1D3-F334-7F4EF95C0CB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4AA2A3C0-A6BC-CFEA-1BA5-D2D091BCFD3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1580D4D0-E7AC-095D-8189-E8B1E1917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8.07.24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A9826D11-32ED-1EA7-6828-4A4FFB829F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DDA3785C-68AA-DC2C-B138-B6AF679D1A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17492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7BD5742-4287-8057-A191-6A053F4E38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FE2C7FDE-190E-26DD-F34F-9C9263B9D2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8.07.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F12296E2-95E1-1F2A-70C8-FA3A3D76F4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716739AE-FC5D-4B79-16C5-01AB0BF4D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8731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C9C7174E-5FDB-DD9C-E6A7-7FC226F3D0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8.07.24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D3C7E267-4700-F33D-8EE1-96678D56FA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4325A6F9-4A30-50AD-B188-8232EFB673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2189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0392367-01E8-206E-5507-BBF59F3AD6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BA3CAA3-1FAC-AE78-A0F2-93F1AB9286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3A45E53A-6AF0-62F1-4C2C-C5EEF88597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1D5E01A-579A-394C-C9FE-C42892EEE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8.07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76D734F-5A7E-41E0-175C-1CBB4AB954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270A3A6-D082-D575-F799-4A1846CA9C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0362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3FBAB11-2E27-58D6-EF3D-B48A9822F0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F4CFB158-BE9A-D8C6-B7C9-1BD3F9A19EB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E8BCFE4-B204-3516-1948-82DA32BBD5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238403A-2655-BAE8-2DCD-7453E2BF31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8.07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388B78C-0FAB-9A09-DC99-989AC76DC2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6D278E3-F04E-953B-3527-1F73468732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82627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2C1717B5-E4FE-97FF-0346-85213A6C9E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00ACD64-039A-15CD-450C-FB9CF31AEF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BF87231-CD82-C03B-E839-39972D33BF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B63150-E30A-4B7C-B836-F6D082E006BA}" type="datetimeFigureOut">
              <a:rPr lang="de-DE" smtClean="0"/>
              <a:t>18.07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EFCAFCF-C32B-30FE-2E2B-ACAFF2BFBE1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2ECC53F-0BA2-9DFB-775D-17F19E73FB0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4631EF-A6EB-4B7C-8CED-D8DDC6D410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37108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 descr="Ein Bild, das Text, Diagramm, Karte, Screenshot enthält.&#10;&#10;Automatisch generierte Beschreibung">
            <a:extLst>
              <a:ext uri="{FF2B5EF4-FFF2-40B4-BE49-F238E27FC236}">
                <a16:creationId xmlns:a16="http://schemas.microsoft.com/office/drawing/2014/main" id="{27243C1C-0D12-87A6-9C43-9E152A8B77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1336" y="234358"/>
            <a:ext cx="10129328" cy="6143051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9592F3C8-3192-6EA8-E36A-216F15E00B69}"/>
              </a:ext>
            </a:extLst>
          </p:cNvPr>
          <p:cNvSpPr txBox="1"/>
          <p:nvPr/>
        </p:nvSpPr>
        <p:spPr>
          <a:xfrm>
            <a:off x="0" y="0"/>
            <a:ext cx="790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Tenorite" panose="00000500000000000000" pitchFamily="2" charset="0"/>
              </a:rPr>
              <a:t>Fig. 3 </a:t>
            </a:r>
          </a:p>
        </p:txBody>
      </p:sp>
    </p:spTree>
    <p:extLst>
      <p:ext uri="{BB962C8B-B14F-4D97-AF65-F5344CB8AC3E}">
        <p14:creationId xmlns:p14="http://schemas.microsoft.com/office/powerpoint/2010/main" val="3847873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 descr="Ein Bild, das Geschirr enthält.&#10;&#10;Automatisch generierte Beschreibung">
            <a:extLst>
              <a:ext uri="{FF2B5EF4-FFF2-40B4-BE49-F238E27FC236}">
                <a16:creationId xmlns:a16="http://schemas.microsoft.com/office/drawing/2014/main" id="{DFC5D0EE-8FF2-178F-5D52-31829D5019E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8128" y="1102659"/>
            <a:ext cx="3489512" cy="4652682"/>
          </a:xfrm>
          <a:prstGeom prst="rect">
            <a:avLst/>
          </a:prstGeom>
        </p:spPr>
      </p:pic>
      <p:pic>
        <p:nvPicPr>
          <p:cNvPr id="7" name="Grafik 6" descr="Ein Bild, das Text, Kreis, Geschirr, Im Haus enthält.&#10;&#10;Automatisch generierte Beschreibung">
            <a:extLst>
              <a:ext uri="{FF2B5EF4-FFF2-40B4-BE49-F238E27FC236}">
                <a16:creationId xmlns:a16="http://schemas.microsoft.com/office/drawing/2014/main" id="{5E371D13-5171-5C14-0CBB-D2265554CA8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1000" y="1102659"/>
            <a:ext cx="6202694" cy="4652682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8EF613DC-2428-1642-4E58-82BF00E10A4D}"/>
              </a:ext>
            </a:extLst>
          </p:cNvPr>
          <p:cNvSpPr txBox="1"/>
          <p:nvPr/>
        </p:nvSpPr>
        <p:spPr>
          <a:xfrm>
            <a:off x="0" y="0"/>
            <a:ext cx="931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Tenorite" panose="00000500000000000000" pitchFamily="2" charset="0"/>
              </a:rPr>
              <a:t>Fig. 3A </a:t>
            </a:r>
          </a:p>
        </p:txBody>
      </p:sp>
    </p:spTree>
    <p:extLst>
      <p:ext uri="{BB962C8B-B14F-4D97-AF65-F5344CB8AC3E}">
        <p14:creationId xmlns:p14="http://schemas.microsoft.com/office/powerpoint/2010/main" val="23558280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 descr="Ein Bild, das Screenshot, Schwarz, Schwarzweiß, monochrom enthält.&#10;&#10;Automatisch generierte Beschreibung">
            <a:extLst>
              <a:ext uri="{FF2B5EF4-FFF2-40B4-BE49-F238E27FC236}">
                <a16:creationId xmlns:a16="http://schemas.microsoft.com/office/drawing/2014/main" id="{57618A09-FDBD-EE28-6D25-08F7E62FED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9303" y="1102659"/>
            <a:ext cx="5777988" cy="4195482"/>
          </a:xfrm>
          <a:prstGeom prst="rect">
            <a:avLst/>
          </a:prstGeom>
        </p:spPr>
      </p:pic>
      <p:pic>
        <p:nvPicPr>
          <p:cNvPr id="5" name="Grafik 4" descr="Ein Bild, das Screenshot, Schwarz, Schwarzweiß, monochrom enthält.&#10;&#10;Automatisch generierte Beschreibung">
            <a:extLst>
              <a:ext uri="{FF2B5EF4-FFF2-40B4-BE49-F238E27FC236}">
                <a16:creationId xmlns:a16="http://schemas.microsoft.com/office/drawing/2014/main" id="{FEF4CFEE-5ADC-8D4D-2B83-6503E6AB38E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012" y="1102659"/>
            <a:ext cx="5777988" cy="4195482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5CFF1841-CF0A-BB4D-5FC4-FD99CAE3F5F1}"/>
              </a:ext>
            </a:extLst>
          </p:cNvPr>
          <p:cNvSpPr txBox="1"/>
          <p:nvPr/>
        </p:nvSpPr>
        <p:spPr>
          <a:xfrm>
            <a:off x="0" y="0"/>
            <a:ext cx="9236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Tenorite" panose="00000500000000000000" pitchFamily="2" charset="0"/>
              </a:rPr>
              <a:t>Fig. 3B </a:t>
            </a:r>
          </a:p>
        </p:txBody>
      </p:sp>
    </p:spTree>
    <p:extLst>
      <p:ext uri="{BB962C8B-B14F-4D97-AF65-F5344CB8AC3E}">
        <p14:creationId xmlns:p14="http://schemas.microsoft.com/office/powerpoint/2010/main" val="26725742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Objekt 15">
            <a:extLst>
              <a:ext uri="{FF2B5EF4-FFF2-40B4-BE49-F238E27FC236}">
                <a16:creationId xmlns:a16="http://schemas.microsoft.com/office/drawing/2014/main" id="{FA9FAA41-D909-FDF2-69EC-7C1D30762A1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54099744"/>
              </p:ext>
            </p:extLst>
          </p:nvPr>
        </p:nvGraphicFramePr>
        <p:xfrm>
          <a:off x="4051271" y="1791484"/>
          <a:ext cx="3954463" cy="3006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954458" imgH="3006399" progId="Prism8.Document">
                  <p:embed/>
                </p:oleObj>
              </mc:Choice>
              <mc:Fallback>
                <p:oleObj name="Prism 8" r:id="rId2" imgW="3954458" imgH="3006399" progId="Prism8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EEA24843-89A1-63AE-CA76-45FE647833B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051271" y="1791484"/>
                        <a:ext cx="3954463" cy="3006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hteck 3">
            <a:extLst>
              <a:ext uri="{FF2B5EF4-FFF2-40B4-BE49-F238E27FC236}">
                <a16:creationId xmlns:a16="http://schemas.microsoft.com/office/drawing/2014/main" id="{1373F25A-DB8A-041E-022A-064EE47440C2}"/>
              </a:ext>
            </a:extLst>
          </p:cNvPr>
          <p:cNvSpPr/>
          <p:nvPr/>
        </p:nvSpPr>
        <p:spPr>
          <a:xfrm>
            <a:off x="6169730" y="2375958"/>
            <a:ext cx="183445" cy="95955"/>
          </a:xfrm>
          <a:prstGeom prst="rect">
            <a:avLst/>
          </a:prstGeom>
          <a:solidFill>
            <a:srgbClr val="55A0F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" name="Rechteck 4">
            <a:extLst>
              <a:ext uri="{FF2B5EF4-FFF2-40B4-BE49-F238E27FC236}">
                <a16:creationId xmlns:a16="http://schemas.microsoft.com/office/drawing/2014/main" id="{CDD773A3-F2DE-B60E-1110-4BD402ED077C}"/>
              </a:ext>
            </a:extLst>
          </p:cNvPr>
          <p:cNvSpPr/>
          <p:nvPr/>
        </p:nvSpPr>
        <p:spPr>
          <a:xfrm>
            <a:off x="5085997" y="2375958"/>
            <a:ext cx="183445" cy="95955"/>
          </a:xfrm>
          <a:prstGeom prst="rect">
            <a:avLst/>
          </a:prstGeom>
          <a:solidFill>
            <a:srgbClr val="FFA04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2F3D7DA1-91B5-79D9-C41D-B46005A0673C}"/>
              </a:ext>
            </a:extLst>
          </p:cNvPr>
          <p:cNvSpPr txBox="1"/>
          <p:nvPr/>
        </p:nvSpPr>
        <p:spPr>
          <a:xfrm>
            <a:off x="0" y="0"/>
            <a:ext cx="8675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Tenorite" panose="00000500000000000000" pitchFamily="2" charset="0"/>
              </a:rPr>
              <a:t>Fig. 3C</a:t>
            </a:r>
          </a:p>
        </p:txBody>
      </p:sp>
    </p:spTree>
    <p:extLst>
      <p:ext uri="{BB962C8B-B14F-4D97-AF65-F5344CB8AC3E}">
        <p14:creationId xmlns:p14="http://schemas.microsoft.com/office/powerpoint/2010/main" val="423351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e 4">
            <a:extLst>
              <a:ext uri="{FF2B5EF4-FFF2-40B4-BE49-F238E27FC236}">
                <a16:creationId xmlns:a16="http://schemas.microsoft.com/office/drawing/2014/main" id="{5A2D9CC3-9364-7F2F-D23D-D95E5B191FB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87338304"/>
              </p:ext>
            </p:extLst>
          </p:nvPr>
        </p:nvGraphicFramePr>
        <p:xfrm>
          <a:off x="722363" y="1529218"/>
          <a:ext cx="10515599" cy="3238540"/>
        </p:xfrm>
        <a:graphic>
          <a:graphicData uri="http://schemas.openxmlformats.org/drawingml/2006/table">
            <a:tbl>
              <a:tblPr/>
              <a:tblGrid>
                <a:gridCol w="3313991">
                  <a:extLst>
                    <a:ext uri="{9D8B030D-6E8A-4147-A177-3AD203B41FA5}">
                      <a16:colId xmlns:a16="http://schemas.microsoft.com/office/drawing/2014/main" val="34891173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1071368268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810565321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3026918953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3503960869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84840720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3033739630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997594903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3689895097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3289988480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702849185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1063581980"/>
                    </a:ext>
                  </a:extLst>
                </a:gridCol>
                <a:gridCol w="600134">
                  <a:extLst>
                    <a:ext uri="{9D8B030D-6E8A-4147-A177-3AD203B41FA5}">
                      <a16:colId xmlns:a16="http://schemas.microsoft.com/office/drawing/2014/main" val="940209027"/>
                    </a:ext>
                  </a:extLst>
                </a:gridCol>
              </a:tblGrid>
              <a:tr h="216710">
                <a:tc>
                  <a:txBody>
                    <a:bodyPr/>
                    <a:lstStyle/>
                    <a:p>
                      <a:pPr algn="l" fontAlgn="b"/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st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nd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rd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98743861"/>
                  </a:ext>
                </a:extLst>
              </a:tr>
              <a:tr h="216710">
                <a:tc>
                  <a:txBody>
                    <a:bodyPr/>
                    <a:lstStyle/>
                    <a:p>
                      <a:pPr algn="l" fontAlgn="b"/>
                      <a:endParaRPr lang="de-DE" sz="13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D420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D59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D420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D59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D420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D59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3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3952009"/>
                  </a:ext>
                </a:extLst>
              </a:tr>
              <a:tr h="14860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3331 (control)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2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5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,3306522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3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86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,6267308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3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8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,1975614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51892029"/>
                  </a:ext>
                </a:extLst>
              </a:tr>
              <a:tr h="14860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3331 (Fe)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46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4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,217458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4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0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,031195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4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14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,209649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6114881"/>
                  </a:ext>
                </a:extLst>
              </a:tr>
              <a:tr h="14860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3366 (control)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0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0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48909756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8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0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8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5361764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2401669"/>
                  </a:ext>
                </a:extLst>
              </a:tr>
              <a:tr h="14860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3366 (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1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1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,17800469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1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70727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0106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1146526"/>
                  </a:ext>
                </a:extLst>
              </a:tr>
              <a:tr h="14860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3356 (control)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52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7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4,2353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6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8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5,6207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7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8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8,0662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8138072"/>
                  </a:ext>
                </a:extLst>
              </a:tr>
              <a:tr h="14860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3356 (Fe)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94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02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67,44198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0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4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6,7761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6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1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0,41108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52568128"/>
                  </a:ext>
                </a:extLst>
              </a:tr>
              <a:tr h="14860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3361 (control)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3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48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89,97758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62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79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0,7435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54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68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9,51672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7160744"/>
                  </a:ext>
                </a:extLst>
              </a:tr>
              <a:tr h="14860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3361 (Fe)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18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40,62936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1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29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03,35284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06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28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6,52947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81228798"/>
                  </a:ext>
                </a:extLst>
              </a:tr>
              <a:tr h="14860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3331 + pGP3897 (control)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5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2,94811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5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62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5,911532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468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9,2402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00850236"/>
                  </a:ext>
                </a:extLst>
              </a:tr>
              <a:tr h="148601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3331 + pGP3897 (Fe)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5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3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4,614179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2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73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6,192671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192" marR="6192" marT="6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34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85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8,064824</a:t>
                      </a:r>
                    </a:p>
                  </a:txBody>
                  <a:tcPr marL="6192" marR="6192" marT="6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05264724"/>
                  </a:ext>
                </a:extLst>
              </a:tr>
            </a:tbl>
          </a:graphicData>
        </a:graphic>
      </p:graphicFrame>
      <p:sp>
        <p:nvSpPr>
          <p:cNvPr id="6" name="Textfeld 5">
            <a:extLst>
              <a:ext uri="{FF2B5EF4-FFF2-40B4-BE49-F238E27FC236}">
                <a16:creationId xmlns:a16="http://schemas.microsoft.com/office/drawing/2014/main" id="{27377D06-6A70-6F1D-F247-5621BD2A264D}"/>
              </a:ext>
            </a:extLst>
          </p:cNvPr>
          <p:cNvSpPr txBox="1"/>
          <p:nvPr/>
        </p:nvSpPr>
        <p:spPr>
          <a:xfrm>
            <a:off x="0" y="0"/>
            <a:ext cx="21151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Tenorite" panose="00000500000000000000" pitchFamily="2" charset="0"/>
              </a:rPr>
              <a:t>Fig. 3C (Raw </a:t>
            </a:r>
            <a:r>
              <a:rPr lang="de-DE" dirty="0" err="1">
                <a:latin typeface="Tenorite" panose="00000500000000000000" pitchFamily="2" charset="0"/>
              </a:rPr>
              <a:t>data</a:t>
            </a:r>
            <a:r>
              <a:rPr lang="de-DE" dirty="0">
                <a:latin typeface="Tenorite" panose="00000500000000000000" pitchFamily="2" charset="0"/>
              </a:rPr>
              <a:t>) </a:t>
            </a:r>
          </a:p>
        </p:txBody>
      </p:sp>
    </p:spTree>
    <p:extLst>
      <p:ext uri="{BB962C8B-B14F-4D97-AF65-F5344CB8AC3E}">
        <p14:creationId xmlns:p14="http://schemas.microsoft.com/office/powerpoint/2010/main" val="36489905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1</Words>
  <Application>Microsoft Macintosh PowerPoint</Application>
  <PresentationFormat>Breitbild</PresentationFormat>
  <Paragraphs>150</Paragraphs>
  <Slides>5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Tenorite</vt:lpstr>
      <vt:lpstr>Office</vt:lpstr>
      <vt:lpstr>Prism 8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obert Warneke</dc:creator>
  <cp:lastModifiedBy>Jörg Stülke</cp:lastModifiedBy>
  <cp:revision>5</cp:revision>
  <dcterms:created xsi:type="dcterms:W3CDTF">2024-07-15T14:26:38Z</dcterms:created>
  <dcterms:modified xsi:type="dcterms:W3CDTF">2024-07-18T14:01:59Z</dcterms:modified>
</cp:coreProperties>
</file>